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320" r:id="rId2"/>
    <p:sldId id="307" r:id="rId3"/>
    <p:sldId id="321" r:id="rId4"/>
    <p:sldId id="310" r:id="rId5"/>
    <p:sldId id="312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025" autoAdjust="0"/>
    <p:restoredTop sz="88218" autoAdjust="0"/>
  </p:normalViewPr>
  <p:slideViewPr>
    <p:cSldViewPr snapToGrid="0" showGuides="1">
      <p:cViewPr varScale="1">
        <p:scale>
          <a:sx n="72" d="100"/>
          <a:sy n="72" d="100"/>
        </p:scale>
        <p:origin x="1848" y="6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8CC13BB-12E1-42D1-8698-D9E37F457E4F}" type="datetimeFigureOut">
              <a:rPr lang="en-US" smtClean="0"/>
              <a:t>5/21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1A8983B-10EB-4B0A-A544-49141581C0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19343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29579">
              <a:defRPr/>
            </a:pPr>
            <a:r>
              <a:rPr lang="en-US" b="0" i="0" dirty="0">
                <a:solidFill>
                  <a:srgbClr val="000000"/>
                </a:solidFill>
                <a:effectLst/>
                <a:latin typeface="Inter"/>
              </a:rPr>
              <a:t>S1: Venn diagram demonstrates the similarities of human exosomal proteome among lymph, plasma, and melanoma cell. </a:t>
            </a:r>
            <a:r>
              <a:rPr lang="en-US" dirty="0"/>
              <a:t>Comparative analysis of the lymphatic exosome cargo with human plasma and melanoma cells shows a higher overlap of the human melanoma lymphatic exosome proteome with lymphatic exosomes compared to human plasma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B6CA564-E0D4-49C4-8ADD-06ECE52FFF40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90438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2: Volcano plot of exosomal proteomic cargo altered in postoperative lymph compared to intraoperative control afferent channel lymph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1A8983B-10EB-4B0A-A544-49141581C056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872859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0" i="0" dirty="0">
                <a:solidFill>
                  <a:srgbClr val="000000"/>
                </a:solidFill>
                <a:effectLst/>
                <a:latin typeface="Inter"/>
              </a:rPr>
              <a:t>S3. Reactome pathways enrichment analysis of all upregulated and downregulated proteins in lymphocele and melanoma lymphatic exosomes. D. </a:t>
            </a:r>
            <a:r>
              <a:rPr lang="en-US" b="0" i="0" dirty="0">
                <a:solidFill>
                  <a:srgbClr val="1C1C1C"/>
                </a:solidFill>
                <a:effectLst/>
                <a:latin typeface="Inter"/>
              </a:rPr>
              <a:t>Network analysis emphasizes the interferon gamma (IFN) pathway mediated PDL1 checkpoint pathway within the results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B6CA564-E0D4-49C4-8ADD-06ECE52FFF40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104076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0" i="0" dirty="0">
                <a:solidFill>
                  <a:srgbClr val="000000"/>
                </a:solidFill>
                <a:effectLst/>
                <a:latin typeface="Inter"/>
              </a:rPr>
              <a:t>S4: Multiplex immunofluorescence (MxIF) shows the expression of exosomal proteomic signatures, including Tenascin C, Galectin-9, and CD38, as well as the pathway enrichment molecules GAS and PDL1 in sentinel lymph node (SLN) tissues, which are considered immunosuppressive marker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B6CA564-E0D4-49C4-8ADD-06ECE52FFF40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478412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F24731-7C05-D3A6-9338-D4A483C1159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D2C91EB-7D85-E123-B4A0-78A3E12FC07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3E6C39-2B2B-B887-D9FA-E1EF038226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A2484-AAD6-48D9-AF5A-26149AA5EFC2}" type="datetimeFigureOut">
              <a:rPr lang="en-US" smtClean="0"/>
              <a:t>5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022999-D349-1902-B19D-EEEA5E3757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4D4F9F-CD22-D8A4-612F-DB0BAF03AD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C449C4-E5FE-472F-AEE7-73FF6F466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16863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8F8FEB-FDC7-178B-C336-FC52BCA4A4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69200B3-7928-8D12-52F5-F991FBF4BD2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6A8F5A-FA12-BCB1-F322-25682D03F1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A2484-AAD6-48D9-AF5A-26149AA5EFC2}" type="datetimeFigureOut">
              <a:rPr lang="en-US" smtClean="0"/>
              <a:t>5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08534C-03CE-FD18-BCE1-995339CD1B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33B026-F9A7-9793-A7ED-0C65F46C92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C449C4-E5FE-472F-AEE7-73FF6F466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53934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A039427-A4B5-4D44-C013-E4DF1C1EE1B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EBB72BC-CD54-E0B2-69AC-75D0054EAEB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770A97-47B8-20AA-97C6-D8CCD8E7EC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A2484-AAD6-48D9-AF5A-26149AA5EFC2}" type="datetimeFigureOut">
              <a:rPr lang="en-US" smtClean="0"/>
              <a:t>5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B9311A-1943-92D3-8216-56B1684E6C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814BD6-B043-ED7A-161F-00B4BE9C73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C449C4-E5FE-472F-AEE7-73FF6F466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64682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DE3D18-EC00-8D62-B247-F15CC83F7D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59E9ED0-D5A2-BA07-7882-7C3DB3D4146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9751C9-5B34-1615-1733-99A89D704D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A2484-AAD6-48D9-AF5A-26149AA5EFC2}" type="datetimeFigureOut">
              <a:rPr lang="en-US" smtClean="0"/>
              <a:t>5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DF80E8-A2E8-6C73-8DF2-E0546309E5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3E22C7-E3DA-B7DC-5C60-385DBDC91F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C449C4-E5FE-472F-AEE7-73FF6F466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35537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92F92E-4C18-6069-12CB-C8F6540AB7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5B264C5-F851-D2B7-2899-0E30F6C1AA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F4AB1B-B18D-5C7E-A0ED-2447286D86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A2484-AAD6-48D9-AF5A-26149AA5EFC2}" type="datetimeFigureOut">
              <a:rPr lang="en-US" smtClean="0"/>
              <a:t>5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2D2E4B-C469-DA10-BD37-B22B6449B6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F1AE6C-E5C0-1CFA-FDC2-43B4F45661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C449C4-E5FE-472F-AEE7-73FF6F466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08409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EC46AA-4415-EB3C-4747-1859B260EE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3354A00-DBFA-71F0-BB25-1E186F17D8C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DAC3794-6B80-8F2F-A41D-B76EBF74BD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03356C1-CD7A-1CBA-7166-AE83A0D44D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A2484-AAD6-48D9-AF5A-26149AA5EFC2}" type="datetimeFigureOut">
              <a:rPr lang="en-US" smtClean="0"/>
              <a:t>5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0AF2CF-8841-6F9A-9828-5068470EB8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A497FC3-30EC-125A-3D0F-7D958FBA26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C449C4-E5FE-472F-AEE7-73FF6F466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77534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C88867-F079-B9E6-D76A-FC0DEA76E3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EB01A4A-A880-9443-B0A7-F9C6DC8EBD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934EC15-3B75-F1EC-E270-0C74A0E91E3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2D038DB-7B03-FB16-1206-7B1AB177ACB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4A475F4-4E78-E458-BD13-228DDA35980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0851254-AE46-76F0-8DB0-98ECF445FA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A2484-AAD6-48D9-AF5A-26149AA5EFC2}" type="datetimeFigureOut">
              <a:rPr lang="en-US" smtClean="0"/>
              <a:t>5/21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DBCDB68-777E-CE77-ED00-A930AEE328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9231C84-0330-DEBB-2FE1-37AA369999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C449C4-E5FE-472F-AEE7-73FF6F466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96356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C10A0B-73BD-2219-0D27-0D87156431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FC11E68-61DF-B56F-0891-C898137666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A2484-AAD6-48D9-AF5A-26149AA5EFC2}" type="datetimeFigureOut">
              <a:rPr lang="en-US" smtClean="0"/>
              <a:t>5/21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86A7DB7-28A8-4882-8248-FD049E0DF8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556539F-E5D5-26A8-8BA6-4F4D2099FE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C449C4-E5FE-472F-AEE7-73FF6F466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41382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243E62B-E711-B4FD-60A8-3CCD5E1B13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A2484-AAD6-48D9-AF5A-26149AA5EFC2}" type="datetimeFigureOut">
              <a:rPr lang="en-US" smtClean="0"/>
              <a:t>5/21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03F7179-0A5A-F2FD-7FE5-23076F2B93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21FBB6C-C153-1BFE-26C7-6B52C8270F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C449C4-E5FE-472F-AEE7-73FF6F466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33082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9E2561-9E1E-039B-D0B2-24B9394BAF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C2A84A5-804B-76BB-52B8-5D247915E5B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A931FD9-D4B2-CE3A-C3B8-38CCEB9735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C2F3CD3-A271-908E-DCCC-6CCE6742DE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A2484-AAD6-48D9-AF5A-26149AA5EFC2}" type="datetimeFigureOut">
              <a:rPr lang="en-US" smtClean="0"/>
              <a:t>5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2A0C7C3-8542-6F98-74CC-AD4C92214F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5C6A277-6B91-DC14-34F0-A9D4B054B3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C449C4-E5FE-472F-AEE7-73FF6F466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59169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0A3B2F-7256-244A-EE2F-9AC67E5BAD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C364497-2B45-626A-DA44-D9AAA76EF52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4DD7CC5-BF7F-288B-6BCF-81DCDAFCF17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21EF70-B015-9AAC-2501-459F8D423C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A2484-AAD6-48D9-AF5A-26149AA5EFC2}" type="datetimeFigureOut">
              <a:rPr lang="en-US" smtClean="0"/>
              <a:t>5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93C36DE-389A-7B0D-D7D5-FFB9701835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7035F31-4297-C415-EA40-3D7FEACBF6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C449C4-E5FE-472F-AEE7-73FF6F466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04520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FF5BEA6-DF99-CC14-C0E8-F608D4F3AD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25F751C-33F6-B909-11C4-A6541A37A5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C7CB0D-2F3F-82F5-A365-1C7694E2C1D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55A2484-AAD6-48D9-AF5A-26149AA5EFC2}" type="datetimeFigureOut">
              <a:rPr lang="en-US" smtClean="0"/>
              <a:t>5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7E5AF9-DAA6-2F09-0ACB-B834A2005B4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986E2C-6F2A-B737-606D-7DAFA4CD611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0C449C4-E5FE-472F-AEE7-73FF6F466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20708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2A97206-FDA0-69D0-DC30-4C10A1D4B66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255770" y="2957195"/>
            <a:ext cx="3596640" cy="768985"/>
          </a:xfrm>
        </p:spPr>
        <p:txBody>
          <a:bodyPr>
            <a:normAutofit fontScale="92500"/>
          </a:bodyPr>
          <a:lstStyle/>
          <a:p>
            <a:pPr marL="0" indent="0">
              <a:buNone/>
            </a:pPr>
            <a:r>
              <a:rPr lang="en-US" dirty="0"/>
              <a:t>Supplementary Figures</a:t>
            </a:r>
          </a:p>
        </p:txBody>
      </p:sp>
    </p:spTree>
    <p:extLst>
      <p:ext uri="{BB962C8B-B14F-4D97-AF65-F5344CB8AC3E}">
        <p14:creationId xmlns:p14="http://schemas.microsoft.com/office/powerpoint/2010/main" val="11746246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A63854D2-8517-C9E5-E9B4-C43980A4F1BD}"/>
              </a:ext>
            </a:extLst>
          </p:cNvPr>
          <p:cNvGrpSpPr/>
          <p:nvPr/>
        </p:nvGrpSpPr>
        <p:grpSpPr>
          <a:xfrm>
            <a:off x="4474964" y="1559940"/>
            <a:ext cx="3242071" cy="3405760"/>
            <a:chOff x="402693" y="837890"/>
            <a:chExt cx="2698637" cy="2781610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6DF01007-FAAF-08B3-BB24-8D977193A946}"/>
                </a:ext>
              </a:extLst>
            </p:cNvPr>
            <p:cNvGrpSpPr/>
            <p:nvPr/>
          </p:nvGrpSpPr>
          <p:grpSpPr>
            <a:xfrm>
              <a:off x="402693" y="837890"/>
              <a:ext cx="2698637" cy="2781610"/>
              <a:chOff x="261379" y="837890"/>
              <a:chExt cx="2201283" cy="2278147"/>
            </a:xfrm>
          </p:grpSpPr>
          <p:sp>
            <p:nvSpPr>
              <p:cNvPr id="17" name="Oval 16">
                <a:extLst>
                  <a:ext uri="{FF2B5EF4-FFF2-40B4-BE49-F238E27FC236}">
                    <a16:creationId xmlns:a16="http://schemas.microsoft.com/office/drawing/2014/main" id="{4380A4EC-D37E-A14A-9CDE-240BB44BD376}"/>
                  </a:ext>
                </a:extLst>
              </p:cNvPr>
              <p:cNvSpPr/>
              <p:nvPr/>
            </p:nvSpPr>
            <p:spPr>
              <a:xfrm>
                <a:off x="261379" y="837890"/>
                <a:ext cx="1455294" cy="1408300"/>
              </a:xfrm>
              <a:prstGeom prst="ellipse">
                <a:avLst/>
              </a:prstGeom>
              <a:solidFill>
                <a:schemeClr val="tx2">
                  <a:lumMod val="10000"/>
                  <a:lumOff val="90000"/>
                </a:schemeClr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8" name="Oval 17">
                <a:extLst>
                  <a:ext uri="{FF2B5EF4-FFF2-40B4-BE49-F238E27FC236}">
                    <a16:creationId xmlns:a16="http://schemas.microsoft.com/office/drawing/2014/main" id="{995CACC2-95B0-882D-AF2C-DF81A9765DC8}"/>
                  </a:ext>
                </a:extLst>
              </p:cNvPr>
              <p:cNvSpPr/>
              <p:nvPr/>
            </p:nvSpPr>
            <p:spPr>
              <a:xfrm>
                <a:off x="1007368" y="837890"/>
                <a:ext cx="1455294" cy="1408300"/>
              </a:xfrm>
              <a:prstGeom prst="ellipse">
                <a:avLst/>
              </a:prstGeom>
              <a:solidFill>
                <a:schemeClr val="accent2">
                  <a:lumMod val="60000"/>
                  <a:lumOff val="40000"/>
                  <a:alpha val="12000"/>
                </a:schemeClr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9" name="Oval 18">
                <a:extLst>
                  <a:ext uri="{FF2B5EF4-FFF2-40B4-BE49-F238E27FC236}">
                    <a16:creationId xmlns:a16="http://schemas.microsoft.com/office/drawing/2014/main" id="{F99099C2-6955-6CCA-81A5-51056410E715}"/>
                  </a:ext>
                </a:extLst>
              </p:cNvPr>
              <p:cNvSpPr/>
              <p:nvPr/>
            </p:nvSpPr>
            <p:spPr>
              <a:xfrm>
                <a:off x="645245" y="1707737"/>
                <a:ext cx="1455294" cy="1408300"/>
              </a:xfrm>
              <a:prstGeom prst="ellipse">
                <a:avLst/>
              </a:prstGeom>
              <a:solidFill>
                <a:schemeClr val="accent3">
                  <a:lumMod val="20000"/>
                  <a:lumOff val="80000"/>
                  <a:alpha val="12000"/>
                </a:schemeClr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</p:grp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C366DCE2-F6B2-8226-CDF9-5563AC56D17E}"/>
                </a:ext>
              </a:extLst>
            </p:cNvPr>
            <p:cNvSpPr txBox="1"/>
            <p:nvPr/>
          </p:nvSpPr>
          <p:spPr>
            <a:xfrm>
              <a:off x="629989" y="1563446"/>
              <a:ext cx="600706" cy="377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3179</a:t>
              </a:r>
            </a:p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(74.5%)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C12F5124-F1DB-A8A1-D5CA-059A1C155AF5}"/>
                </a:ext>
              </a:extLst>
            </p:cNvPr>
            <p:cNvSpPr txBox="1"/>
            <p:nvPr/>
          </p:nvSpPr>
          <p:spPr>
            <a:xfrm>
              <a:off x="1467157" y="1407913"/>
              <a:ext cx="600706" cy="377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657</a:t>
              </a:r>
            </a:p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(15.4%)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679D77AD-74F1-16B2-DB57-F66C78EDBE1C}"/>
                </a:ext>
              </a:extLst>
            </p:cNvPr>
            <p:cNvSpPr txBox="1"/>
            <p:nvPr/>
          </p:nvSpPr>
          <p:spPr>
            <a:xfrm>
              <a:off x="2354542" y="1737068"/>
              <a:ext cx="487290" cy="377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87</a:t>
              </a:r>
            </a:p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(4.4%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DE80DD9-31D0-2F74-646F-87BFF1517205}"/>
                </a:ext>
              </a:extLst>
            </p:cNvPr>
            <p:cNvSpPr txBox="1"/>
            <p:nvPr/>
          </p:nvSpPr>
          <p:spPr>
            <a:xfrm>
              <a:off x="1108193" y="2209661"/>
              <a:ext cx="529988" cy="377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2</a:t>
              </a:r>
            </a:p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(1.2%)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20947A81-EF82-BF98-DD8E-9B8BFE116D0E}"/>
                </a:ext>
              </a:extLst>
            </p:cNvPr>
            <p:cNvSpPr txBox="1"/>
            <p:nvPr/>
          </p:nvSpPr>
          <p:spPr>
            <a:xfrm>
              <a:off x="1574024" y="1990412"/>
              <a:ext cx="423244" cy="377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41</a:t>
              </a:r>
            </a:p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(1%)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291ED3AA-14B9-E71E-0EE1-7416F1A50878}"/>
                </a:ext>
              </a:extLst>
            </p:cNvPr>
            <p:cNvSpPr txBox="1"/>
            <p:nvPr/>
          </p:nvSpPr>
          <p:spPr>
            <a:xfrm>
              <a:off x="2028802" y="2179765"/>
              <a:ext cx="651481" cy="377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4 </a:t>
              </a:r>
            </a:p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(0.1%)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419DC6DE-0E37-C018-92C5-143DBB266C6C}"/>
                </a:ext>
              </a:extLst>
            </p:cNvPr>
            <p:cNvSpPr txBox="1"/>
            <p:nvPr/>
          </p:nvSpPr>
          <p:spPr>
            <a:xfrm>
              <a:off x="1416382" y="2733934"/>
              <a:ext cx="651481" cy="377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47</a:t>
              </a:r>
            </a:p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(3.4%)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649D6F9E-0769-A349-CBFA-78E3CE6435A2}"/>
                </a:ext>
              </a:extLst>
            </p:cNvPr>
            <p:cNvSpPr txBox="1"/>
            <p:nvPr/>
          </p:nvSpPr>
          <p:spPr>
            <a:xfrm>
              <a:off x="506811" y="1194347"/>
              <a:ext cx="99645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chemeClr val="accent4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ymphatic exosomes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935028EA-414E-331D-F695-79ADB2F596A9}"/>
                </a:ext>
              </a:extLst>
            </p:cNvPr>
            <p:cNvSpPr txBox="1"/>
            <p:nvPr/>
          </p:nvSpPr>
          <p:spPr>
            <a:xfrm>
              <a:off x="2160552" y="1207909"/>
              <a:ext cx="890477" cy="5278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F9927D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uman melanoma </a:t>
              </a:r>
            </a:p>
            <a:p>
              <a:r>
                <a:rPr lang="en-US" sz="1200" b="1" dirty="0">
                  <a:solidFill>
                    <a:srgbClr val="F9927D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xoCarta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F5FB5237-B504-C28B-D2DA-11F029E084E6}"/>
                </a:ext>
              </a:extLst>
            </p:cNvPr>
            <p:cNvSpPr txBox="1"/>
            <p:nvPr/>
          </p:nvSpPr>
          <p:spPr>
            <a:xfrm>
              <a:off x="1191955" y="3060278"/>
              <a:ext cx="1063711" cy="377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schemeClr val="accent6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uman plasma</a:t>
              </a:r>
            </a:p>
            <a:p>
              <a:pPr algn="ctr"/>
              <a:r>
                <a:rPr lang="en-US" sz="1200" b="1" dirty="0">
                  <a:solidFill>
                    <a:schemeClr val="accent6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xoCarta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9F7855AC-64D5-A021-3F32-449495A77E44}"/>
              </a:ext>
            </a:extLst>
          </p:cNvPr>
          <p:cNvSpPr txBox="1"/>
          <p:nvPr/>
        </p:nvSpPr>
        <p:spPr>
          <a:xfrm>
            <a:off x="4669035" y="646284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/>
              <a:t>Supplementary </a:t>
            </a:r>
            <a:r>
              <a:rPr lang="en-US" dirty="0"/>
              <a:t>Fig S1</a:t>
            </a:r>
            <a:r>
              <a:rPr lang="en-US" sz="1800" dirty="0"/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784582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9" name="Object 18">
            <a:extLst>
              <a:ext uri="{FF2B5EF4-FFF2-40B4-BE49-F238E27FC236}">
                <a16:creationId xmlns:a16="http://schemas.microsoft.com/office/drawing/2014/main" id="{033F5C8E-8C18-F144-8A9F-2FB43BE2E22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186790" y="1353817"/>
          <a:ext cx="6672931" cy="47675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3774943" imgH="2697194" progId="Prism10.Document">
                  <p:embed/>
                </p:oleObj>
              </mc:Choice>
              <mc:Fallback>
                <p:oleObj name="Prism 10" r:id="rId3" imgW="3774943" imgH="2697194" progId="Prism10.Document">
                  <p:embed/>
                  <p:pic>
                    <p:nvPicPr>
                      <p:cNvPr id="19" name="Object 18">
                        <a:extLst>
                          <a:ext uri="{FF2B5EF4-FFF2-40B4-BE49-F238E27FC236}">
                            <a16:creationId xmlns:a16="http://schemas.microsoft.com/office/drawing/2014/main" id="{033F5C8E-8C18-F144-8A9F-2FB43BE2E22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186790" y="1353817"/>
                        <a:ext cx="6672931" cy="47675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2FE6E5C2-EBE1-BB70-5924-96C5F4D973CF}"/>
              </a:ext>
            </a:extLst>
          </p:cNvPr>
          <p:cNvSpPr txBox="1"/>
          <p:nvPr/>
        </p:nvSpPr>
        <p:spPr>
          <a:xfrm>
            <a:off x="4669035" y="646284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/>
              <a:t>Supplementary </a:t>
            </a:r>
            <a:r>
              <a:rPr lang="en-US" dirty="0"/>
              <a:t>Fig S2</a:t>
            </a:r>
            <a:r>
              <a:rPr lang="en-US" sz="1800" dirty="0"/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567750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 descr="A screen shot of a chart&#10;&#10;AI-generated content may be incorrect.">
            <a:extLst>
              <a:ext uri="{FF2B5EF4-FFF2-40B4-BE49-F238E27FC236}">
                <a16:creationId xmlns:a16="http://schemas.microsoft.com/office/drawing/2014/main" id="{89F2FBD5-C4D8-99B7-B01C-70600AEDF93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8906" y="2230506"/>
            <a:ext cx="5706092" cy="2710394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0049E2DF-585C-BC9E-1FC5-2B241F86576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603168" y="2033595"/>
            <a:ext cx="2389926" cy="3084832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6F5DC0C1-40D3-4060-1AF5-D4D5886C2701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5359" t="18427" r="18127" b="23804"/>
          <a:stretch/>
        </p:blipFill>
        <p:spPr>
          <a:xfrm>
            <a:off x="5904998" y="2230506"/>
            <a:ext cx="3559730" cy="269100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F6A49A06-4914-C063-D499-F375B67546F4}"/>
              </a:ext>
            </a:extLst>
          </p:cNvPr>
          <p:cNvSpPr txBox="1"/>
          <p:nvPr/>
        </p:nvSpPr>
        <p:spPr>
          <a:xfrm>
            <a:off x="4669035" y="646284"/>
            <a:ext cx="26842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/>
              <a:t>Supplementary </a:t>
            </a:r>
            <a:r>
              <a:rPr lang="en-US" dirty="0"/>
              <a:t>Fig S3</a:t>
            </a:r>
            <a:r>
              <a:rPr lang="en-US" sz="1800" dirty="0"/>
              <a:t> </a:t>
            </a:r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A00586E-A19A-B164-532A-6FD3C64729B9}"/>
              </a:ext>
            </a:extLst>
          </p:cNvPr>
          <p:cNvSpPr txBox="1"/>
          <p:nvPr/>
        </p:nvSpPr>
        <p:spPr>
          <a:xfrm>
            <a:off x="2286000" y="1552695"/>
            <a:ext cx="205283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0" i="0" dirty="0">
                <a:solidFill>
                  <a:srgbClr val="000000"/>
                </a:solidFill>
                <a:effectLst/>
                <a:latin typeface="Inter"/>
              </a:rPr>
              <a:t>Reactome pathways </a:t>
            </a:r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7B34244-0336-9111-58ED-E0D4F4628C22}"/>
              </a:ext>
            </a:extLst>
          </p:cNvPr>
          <p:cNvSpPr txBox="1"/>
          <p:nvPr/>
        </p:nvSpPr>
        <p:spPr>
          <a:xfrm>
            <a:off x="6727666" y="1664263"/>
            <a:ext cx="205283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0" i="0" dirty="0">
                <a:solidFill>
                  <a:srgbClr val="000000"/>
                </a:solidFill>
                <a:effectLst/>
                <a:latin typeface="Inter"/>
              </a:rPr>
              <a:t>Reactome pathways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5159875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>
            <a:extLst>
              <a:ext uri="{FF2B5EF4-FFF2-40B4-BE49-F238E27FC236}">
                <a16:creationId xmlns:a16="http://schemas.microsoft.com/office/drawing/2014/main" id="{07FCA105-E392-6D36-5E9C-CE67E650EE53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r="2975" b="19006"/>
          <a:stretch/>
        </p:blipFill>
        <p:spPr>
          <a:xfrm>
            <a:off x="3114597" y="1089289"/>
            <a:ext cx="7030888" cy="560241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6ED4114-2420-C37C-8DA7-613618DE26B8}"/>
              </a:ext>
            </a:extLst>
          </p:cNvPr>
          <p:cNvSpPr txBox="1"/>
          <p:nvPr/>
        </p:nvSpPr>
        <p:spPr>
          <a:xfrm>
            <a:off x="4799664" y="312456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/>
              <a:t>Supplementary </a:t>
            </a:r>
            <a:r>
              <a:rPr lang="en-US" dirty="0"/>
              <a:t>Fig S 4</a:t>
            </a:r>
          </a:p>
        </p:txBody>
      </p:sp>
    </p:spTree>
    <p:extLst>
      <p:ext uri="{BB962C8B-B14F-4D97-AF65-F5344CB8AC3E}">
        <p14:creationId xmlns:p14="http://schemas.microsoft.com/office/powerpoint/2010/main" val="19283824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11372f5f-8e19-4efb-8afe-8eac20a980c4}" enabled="1" method="Standard" siteId="{a25fff9c-3f63-4fb2-9a8a-d9bdd0321f9a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275</TotalTime>
  <Words>217</Words>
  <Application>Microsoft Office PowerPoint</Application>
  <PresentationFormat>Widescreen</PresentationFormat>
  <Paragraphs>34</Paragraphs>
  <Slides>5</Slides>
  <Notes>4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ptos</vt:lpstr>
      <vt:lpstr>Aptos Display</vt:lpstr>
      <vt:lpstr>Arial</vt:lpstr>
      <vt:lpstr>Inter</vt:lpstr>
      <vt:lpstr>Office Theme</vt:lpstr>
      <vt:lpstr>Prism 10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uman, Shankar, Ph.D.</dc:creator>
  <cp:lastModifiedBy>Suman, Shankar, Ph.D.</cp:lastModifiedBy>
  <cp:revision>11</cp:revision>
  <dcterms:created xsi:type="dcterms:W3CDTF">2025-04-02T18:52:17Z</dcterms:created>
  <dcterms:modified xsi:type="dcterms:W3CDTF">2025-05-21T21:52:25Z</dcterms:modified>
</cp:coreProperties>
</file>